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60" r:id="rId1"/>
  </p:sldMasterIdLst>
  <p:notesMasterIdLst>
    <p:notesMasterId r:id="rId8"/>
  </p:notesMasterIdLst>
  <p:sldIdLst>
    <p:sldId id="270" r:id="rId2"/>
    <p:sldId id="269" r:id="rId3"/>
    <p:sldId id="271" r:id="rId4"/>
    <p:sldId id="266" r:id="rId5"/>
    <p:sldId id="272" r:id="rId6"/>
    <p:sldId id="26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5C7BCE3-EF11-33F5-D9D0-D315BB4AD239}" name="Gerisch, Melvin" initials="GM" userId="Gerisch, Melvin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6208" autoAdjust="0"/>
  </p:normalViewPr>
  <p:slideViewPr>
    <p:cSldViewPr snapToGrid="0" showGuides="1">
      <p:cViewPr>
        <p:scale>
          <a:sx n="125" d="100"/>
          <a:sy n="125" d="100"/>
        </p:scale>
        <p:origin x="926" y="-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83A7CC-05EE-4BD5-9155-CB6F104F0685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AF072B-5C49-4FC2-91E0-95B30043B0E9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99578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AF072B-5C49-4FC2-91E0-95B30043B0E9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350751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4228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25703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72693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0994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7335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77405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040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2461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36019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62459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5548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0AD928-7122-44FA-96AA-EACCF887848E}" type="datetimeFigureOut">
              <a:rPr lang="de-DE" smtClean="0"/>
              <a:t>13.10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120A20-0F9D-4073-BB7E-1D4117D0C3AC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2605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1D099657-36DA-22AF-5D40-C0C1D2F445C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624" y="213848"/>
            <a:ext cx="4591050" cy="3856990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0D23B646-0FB8-1156-02DD-462F715B2A46}"/>
              </a:ext>
            </a:extLst>
          </p:cNvPr>
          <p:cNvSpPr txBox="1"/>
          <p:nvPr/>
        </p:nvSpPr>
        <p:spPr>
          <a:xfrm>
            <a:off x="501624" y="4329802"/>
            <a:ext cx="438626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0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igure S1. Patient selection. </a:t>
            </a:r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breviations: IMV = invasive mechanical ventilation, RT-PCR = real-time PCR, w/o = with/without. </a:t>
            </a:r>
            <a:endParaRPr lang="de-DE" sz="1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22321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>
            <a:extLst>
              <a:ext uri="{FF2B5EF4-FFF2-40B4-BE49-F238E27FC236}">
                <a16:creationId xmlns:a16="http://schemas.microsoft.com/office/drawing/2014/main" id="{FC68F54E-0B10-8968-0FA5-99710F6906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1081" y="475094"/>
            <a:ext cx="3773790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16906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1690688" algn="l"/>
              </a:tabLst>
            </a:pPr>
            <a:r>
              <a:rPr kumimoji="0" lang="en-US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1. Composition of Nutritional Inflammation Scores</a:t>
            </a:r>
            <a:endParaRPr kumimoji="0" lang="de-DE" altLang="de-DE" sz="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graphicFrame>
        <p:nvGraphicFramePr>
          <p:cNvPr id="3" name="Tabelle 2">
            <a:extLst>
              <a:ext uri="{FF2B5EF4-FFF2-40B4-BE49-F238E27FC236}">
                <a16:creationId xmlns:a16="http://schemas.microsoft.com/office/drawing/2014/main" id="{A1CE4542-4C95-0DD2-143D-836A082FBF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2856676"/>
              </p:ext>
            </p:extLst>
          </p:nvPr>
        </p:nvGraphicFramePr>
        <p:xfrm>
          <a:off x="301081" y="721315"/>
          <a:ext cx="6255838" cy="3695084"/>
        </p:xfrm>
        <a:graphic>
          <a:graphicData uri="http://schemas.openxmlformats.org/drawingml/2006/table">
            <a:tbl>
              <a:tblPr firstRow="1" firstCol="1" bandRow="1"/>
              <a:tblGrid>
                <a:gridCol w="1764000">
                  <a:extLst>
                    <a:ext uri="{9D8B030D-6E8A-4147-A177-3AD203B41FA5}">
                      <a16:colId xmlns:a16="http://schemas.microsoft.com/office/drawing/2014/main" val="1011311942"/>
                    </a:ext>
                  </a:extLst>
                </a:gridCol>
                <a:gridCol w="2851997">
                  <a:extLst>
                    <a:ext uri="{9D8B030D-6E8A-4147-A177-3AD203B41FA5}">
                      <a16:colId xmlns:a16="http://schemas.microsoft.com/office/drawing/2014/main" val="3952133954"/>
                    </a:ext>
                  </a:extLst>
                </a:gridCol>
                <a:gridCol w="1639841">
                  <a:extLst>
                    <a:ext uri="{9D8B030D-6E8A-4147-A177-3AD203B41FA5}">
                      <a16:colId xmlns:a16="http://schemas.microsoft.com/office/drawing/2014/main" val="3483061160"/>
                    </a:ext>
                  </a:extLst>
                </a:gridCol>
              </a:tblGrid>
              <a:tr h="46800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iochemical characteristics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alculation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eference</a:t>
                      </a:r>
                      <a:endParaRPr lang="de-DE" sz="11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6381436"/>
                  </a:ext>
                </a:extLst>
              </a:tr>
              <a:tr h="39600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odified Glasgow Prognostic Score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octor et al (2011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164227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marL="342900" lvl="0" indent="-342900" algn="l">
                        <a:lnSpc>
                          <a:spcPct val="107000"/>
                        </a:lnSpc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≤ 10 [mg/L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1209098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marL="342900" lvl="0" indent="-342900" algn="l">
                        <a:lnSpc>
                          <a:spcPct val="107000"/>
                        </a:lnSpc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&gt; 10 [mg/L] + </a:t>
                      </a:r>
                      <a:r>
                        <a:rPr lang="de-DE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bumin</a:t>
                      </a: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&gt; 3.5 [g/</a:t>
                      </a:r>
                      <a:r>
                        <a:rPr lang="de-DE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L</a:t>
                      </a: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0539510"/>
                  </a:ext>
                </a:extLst>
              </a:tr>
              <a:tr h="179705">
                <a:tc>
                  <a:txBody>
                    <a:bodyPr/>
                    <a:lstStyle/>
                    <a:p>
                      <a:pPr marL="342900" lvl="0" indent="-342900" algn="l">
                        <a:lnSpc>
                          <a:spcPct val="107000"/>
                        </a:lnSpc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&gt; 10 [mg/L] + </a:t>
                      </a:r>
                      <a:r>
                        <a:rPr lang="de-DE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bumin</a:t>
                      </a: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&lt; 3.5 [g/</a:t>
                      </a:r>
                      <a:r>
                        <a:rPr lang="de-DE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L</a:t>
                      </a: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8283498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1691005" algn="l"/>
                        </a:tabLs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-</a:t>
                      </a:r>
                      <a:r>
                        <a:rPr lang="de-DE" sz="10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o</a:t>
                      </a: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Albumin-Ratio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[mg/L] / </a:t>
                      </a:r>
                      <a:r>
                        <a:rPr lang="de-DE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bumin</a:t>
                      </a: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[g/</a:t>
                      </a:r>
                      <a:r>
                        <a:rPr lang="de-DE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L</a:t>
                      </a: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airclough</a:t>
                      </a: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t al (2009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22678871"/>
                  </a:ext>
                </a:extLst>
              </a:tr>
              <a:tr h="350229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1691005" algn="l"/>
                        </a:tabLst>
                      </a:pPr>
                      <a:r>
                        <a:rPr lang="de-DE" sz="10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ognostic</a:t>
                      </a: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Nutritional Index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bumin level [g/dL] + 0.005 * total lymphocyte count [per mm³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nodera</a:t>
                      </a: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t al (1984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6035482"/>
                  </a:ext>
                </a:extLst>
              </a:tr>
              <a:tr h="435428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1691005" algn="l"/>
                        </a:tabLs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utrophile-to-Lymphocyte-Ratio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eutrophile count [per mm³] / total lymphocyte count [per mm³]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Zahorec</a:t>
                      </a: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t al (2001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2211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  <a:tabLst>
                          <a:tab pos="1691005" algn="l"/>
                        </a:tabLst>
                      </a:pPr>
                      <a:r>
                        <a:rPr lang="en-GB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ognostic Index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de-DE" sz="1000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asymjanova</a:t>
                      </a: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et al (2010)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7330162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342900" lvl="0" indent="-342900" algn="l">
                        <a:lnSpc>
                          <a:spcPct val="107000"/>
                        </a:lnSpc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≤ 10 [mg/L] + WBC CRP ≤ 11x10^9</a:t>
                      </a: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6015240"/>
                  </a:ext>
                </a:extLst>
              </a:tr>
              <a:tr h="252023">
                <a:tc>
                  <a:txBody>
                    <a:bodyPr/>
                    <a:lstStyle/>
                    <a:p>
                      <a:pPr marL="342900" lvl="0" indent="-342900" algn="l">
                        <a:lnSpc>
                          <a:spcPct val="107000"/>
                        </a:lnSpc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≤ 10 [mg/L] + WBC </a:t>
                      </a: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 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x10^9</a:t>
                      </a: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79627647"/>
                  </a:ext>
                </a:extLst>
              </a:tr>
              <a:tr h="223049">
                <a:tc>
                  <a:txBody>
                    <a:bodyPr/>
                    <a:lstStyle/>
                    <a:p>
                      <a:pPr marL="342900" lvl="0" indent="-342900" algn="l">
                        <a:lnSpc>
                          <a:spcPct val="107000"/>
                        </a:lnSpc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</a:t>
                      </a: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10 [mg/L] + WBC CRP ≤ 11x10^9</a:t>
                      </a: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79907323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342900" lvl="0" indent="-342900" algn="l">
                        <a:lnSpc>
                          <a:spcPct val="107000"/>
                        </a:lnSpc>
                        <a:spcAft>
                          <a:spcPts val="800"/>
                        </a:spcAft>
                        <a:buFont typeface="Arial" panose="020B0604020202020204" pitchFamily="34" charset="0"/>
                        <a:buChar char="-"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de-DE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&gt; 10 [mg/L] + 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WBC </a:t>
                      </a:r>
                      <a:r>
                        <a:rPr lang="de-DE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gt; </a:t>
                      </a:r>
                      <a:r>
                        <a:rPr lang="en-US" sz="10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1x10^9</a:t>
                      </a: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10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24424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394591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elle 5">
            <a:extLst>
              <a:ext uri="{FF2B5EF4-FFF2-40B4-BE49-F238E27FC236}">
                <a16:creationId xmlns:a16="http://schemas.microsoft.com/office/drawing/2014/main" id="{F32CEC00-261E-F1D9-561B-D6088503C5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54748124"/>
              </p:ext>
            </p:extLst>
          </p:nvPr>
        </p:nvGraphicFramePr>
        <p:xfrm>
          <a:off x="471487" y="497753"/>
          <a:ext cx="5915025" cy="3732515"/>
        </p:xfrm>
        <a:graphic>
          <a:graphicData uri="http://schemas.openxmlformats.org/drawingml/2006/table">
            <a:tbl>
              <a:tblPr firstRow="1" firstCol="1" bandRow="1"/>
              <a:tblGrid>
                <a:gridCol w="1574580">
                  <a:extLst>
                    <a:ext uri="{9D8B030D-6E8A-4147-A177-3AD203B41FA5}">
                      <a16:colId xmlns:a16="http://schemas.microsoft.com/office/drawing/2014/main" val="113080519"/>
                    </a:ext>
                  </a:extLst>
                </a:gridCol>
                <a:gridCol w="1275279">
                  <a:extLst>
                    <a:ext uri="{9D8B030D-6E8A-4147-A177-3AD203B41FA5}">
                      <a16:colId xmlns:a16="http://schemas.microsoft.com/office/drawing/2014/main" val="1459972646"/>
                    </a:ext>
                  </a:extLst>
                </a:gridCol>
                <a:gridCol w="1125038">
                  <a:extLst>
                    <a:ext uri="{9D8B030D-6E8A-4147-A177-3AD203B41FA5}">
                      <a16:colId xmlns:a16="http://schemas.microsoft.com/office/drawing/2014/main" val="1806208050"/>
                    </a:ext>
                  </a:extLst>
                </a:gridCol>
                <a:gridCol w="1016201">
                  <a:extLst>
                    <a:ext uri="{9D8B030D-6E8A-4147-A177-3AD203B41FA5}">
                      <a16:colId xmlns:a16="http://schemas.microsoft.com/office/drawing/2014/main" val="2316055944"/>
                    </a:ext>
                  </a:extLst>
                </a:gridCol>
                <a:gridCol w="923927">
                  <a:extLst>
                    <a:ext uri="{9D8B030D-6E8A-4147-A177-3AD203B41FA5}">
                      <a16:colId xmlns:a16="http://schemas.microsoft.com/office/drawing/2014/main" val="2090864317"/>
                    </a:ext>
                  </a:extLst>
                </a:gridCol>
              </a:tblGrid>
              <a:tr h="25971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nvasive mechanical ventilat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86006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haracteristic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ll patients</a:t>
                      </a:r>
                      <a:b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N = 58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 (N = 43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s (N = 15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p-values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992477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eason for IMV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212650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ld ARDS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 (20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210348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derate ARDS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 (40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284823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vere ARDS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 (34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739267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rdiac decompensation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(6)</a:t>
                      </a:r>
                      <a:endParaRPr lang="de-DE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7910027"/>
                  </a:ext>
                </a:extLst>
              </a:tr>
              <a:tr h="61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ime from admission to IMV</a:t>
                      </a:r>
                      <a:r>
                        <a:rPr lang="en-US" sz="1000" b="0" baseline="30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median (range) [days]</a:t>
                      </a:r>
                      <a:endParaRPr lang="de-DE" sz="1000" b="1" baseline="30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 (-1–12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980320"/>
                  </a:ext>
                </a:extLst>
              </a:tr>
              <a:tr h="43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IMV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median (range) [days]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 (1–46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829022"/>
                  </a:ext>
                </a:extLst>
              </a:tr>
              <a:tr h="61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uration of </a:t>
                      </a:r>
                      <a:r>
                        <a:rPr lang="en-US" sz="10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ospitalization</a:t>
                      </a:r>
                      <a:r>
                        <a:rPr lang="en-US" sz="1000" b="0" baseline="30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, median (range) [days]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 (1–67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 (1–62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5 (6–67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0003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5608835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aths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 (6.9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 (26.7)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de-DE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9671305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D90FB0DB-A64F-8F9D-F38C-397CB1A937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71488" y="4230268"/>
            <a:ext cx="5915024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l values are shown in number (percent) if not stated otherwise. </a:t>
            </a:r>
            <a:r>
              <a:rPr kumimoji="0" lang="en-US" altLang="de-DE" sz="10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</a:t>
            </a:r>
            <a:r>
              <a:rPr kumimoji="0" lang="en-US" altLang="de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ne patient was intubated on the day prior to admission in external clinic. </a:t>
            </a:r>
            <a:r>
              <a:rPr lang="en-US" altLang="de-DE" sz="1000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 </a:t>
            </a:r>
            <a:r>
              <a:rPr kumimoji="0" lang="en-US" altLang="de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ospitalization is defined as time from admission until discharge, death or data cut-off. Abbreviations: ARDS = acute respiratory distress syndrome, IMV = invasive mechanical ventilation.</a:t>
            </a:r>
            <a:endParaRPr kumimoji="0" lang="en-US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2CDBA5AF-C455-68AA-6783-8E8A8865D243}"/>
              </a:ext>
            </a:extLst>
          </p:cNvPr>
          <p:cNvSpPr txBox="1"/>
          <p:nvPr/>
        </p:nvSpPr>
        <p:spPr>
          <a:xfrm>
            <a:off x="471486" y="251532"/>
            <a:ext cx="59150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2. Additional Patient Characteristics</a:t>
            </a:r>
            <a:endParaRPr kumimoji="0" lang="de-DE" altLang="de-DE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145793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Grafik 10">
            <a:extLst>
              <a:ext uri="{FF2B5EF4-FFF2-40B4-BE49-F238E27FC236}">
                <a16:creationId xmlns:a16="http://schemas.microsoft.com/office/drawing/2014/main" id="{47677202-C309-87FB-61BD-91DD66E0938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745" y="366802"/>
            <a:ext cx="2878789" cy="2880000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C684BA2D-1E4D-A10A-5D2C-E304FE9FB786}"/>
              </a:ext>
            </a:extLst>
          </p:cNvPr>
          <p:cNvSpPr txBox="1"/>
          <p:nvPr/>
        </p:nvSpPr>
        <p:spPr>
          <a:xfrm>
            <a:off x="347745" y="3350871"/>
            <a:ext cx="616069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OC analyses of inflammatory markers for the prediction of invasive mechanical ventilation in COVID-19 patients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bbreviation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: CRP = c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activ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IL-6 = interleukin-6.</a:t>
            </a:r>
          </a:p>
        </p:txBody>
      </p:sp>
    </p:spTree>
    <p:extLst>
      <p:ext uri="{BB962C8B-B14F-4D97-AF65-F5344CB8AC3E}">
        <p14:creationId xmlns:p14="http://schemas.microsoft.com/office/powerpoint/2010/main" val="3197110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le 3">
            <a:extLst>
              <a:ext uri="{FF2B5EF4-FFF2-40B4-BE49-F238E27FC236}">
                <a16:creationId xmlns:a16="http://schemas.microsoft.com/office/drawing/2014/main" id="{8EB74BF2-1C73-B0FF-4DBB-51B079B03D0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1764932"/>
              </p:ext>
            </p:extLst>
          </p:nvPr>
        </p:nvGraphicFramePr>
        <p:xfrm>
          <a:off x="435629" y="531906"/>
          <a:ext cx="5796000" cy="2176874"/>
        </p:xfrm>
        <a:graphic>
          <a:graphicData uri="http://schemas.openxmlformats.org/drawingml/2006/table">
            <a:tbl>
              <a:tblPr firstRow="1" firstCol="1" bandRow="1"/>
              <a:tblGrid>
                <a:gridCol w="1512000">
                  <a:extLst>
                    <a:ext uri="{9D8B030D-6E8A-4147-A177-3AD203B41FA5}">
                      <a16:colId xmlns:a16="http://schemas.microsoft.com/office/drawing/2014/main" val="2105333773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275763542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1184114060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933470337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508284522"/>
                    </a:ext>
                  </a:extLst>
                </a:gridCol>
              </a:tblGrid>
              <a:tr h="258474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vasive mechanical ventilation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81855778"/>
                  </a:ext>
                </a:extLst>
              </a:tr>
              <a:tr h="2922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haracteristic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l patients</a:t>
                      </a:r>
                      <a:br>
                        <a:rPr lang="de-DE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 = 58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</a:t>
                      </a:r>
                      <a:br>
                        <a:rPr lang="de-DE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 = 43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Yes</a:t>
                      </a:r>
                      <a:br>
                        <a:rPr lang="de-DE" sz="1000" b="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N = 15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value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401570"/>
                  </a:ext>
                </a:extLst>
              </a:tr>
              <a:tr h="252000">
                <a:tc gridSpan="2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lammatory Markers</a:t>
                      </a:r>
                    </a:p>
                  </a:txBody>
                  <a:tcPr marL="32226" marR="3222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836014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 [mg/l]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9 (0.1–32.3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9 (0.1–32.3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.8 (2.1–15.2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08</a:t>
                      </a:r>
                      <a:endParaRPr lang="de-DE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322596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rritin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98 (46–9254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6 (46–2415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14 (431–9254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3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960348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terleukin-6 [pg/ml]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9.8 (1.5–233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3.4 (1.5–122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29 (34.8–233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5007688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bumin [mg/l]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7 (2.3–5.1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8 (3.2–5.1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3 (2.3–4.1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01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5298964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Leukocytes [G/l]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3 (2.2–24.7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.1 (2.2–13.7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.6 (2.9–24.7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32226" marR="32226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5690943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4D412748-124D-B746-D054-5264F7F22C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629" y="131796"/>
            <a:ext cx="580277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</a:t>
            </a:r>
            <a:r>
              <a:rPr lang="en-US" altLang="de-DE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3</a:t>
            </a:r>
            <a:r>
              <a:rPr kumimoji="0" lang="en-US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Distribution of Inflammatory </a:t>
            </a:r>
            <a:r>
              <a:rPr lang="en-US" altLang="de-DE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</a:t>
            </a:r>
            <a:r>
              <a:rPr kumimoji="0" lang="en-US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kers B</a:t>
            </a:r>
            <a:r>
              <a:rPr lang="en-US" altLang="de-DE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tween COVID-19 Cohorts Based on IMV Requirement</a:t>
            </a:r>
            <a:endParaRPr kumimoji="0" lang="de-DE" altLang="de-DE" sz="1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78232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elle 7">
            <a:extLst>
              <a:ext uri="{FF2B5EF4-FFF2-40B4-BE49-F238E27FC236}">
                <a16:creationId xmlns:a16="http://schemas.microsoft.com/office/drawing/2014/main" id="{3C9CE256-EBCB-4E23-81A4-A4F414B4E0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1811778"/>
              </p:ext>
            </p:extLst>
          </p:nvPr>
        </p:nvGraphicFramePr>
        <p:xfrm>
          <a:off x="371721" y="522083"/>
          <a:ext cx="6119999" cy="1564800"/>
        </p:xfrm>
        <a:graphic>
          <a:graphicData uri="http://schemas.openxmlformats.org/drawingml/2006/table">
            <a:tbl>
              <a:tblPr firstRow="1" firstCol="1" bandRow="1"/>
              <a:tblGrid>
                <a:gridCol w="1151999">
                  <a:extLst>
                    <a:ext uri="{9D8B030D-6E8A-4147-A177-3AD203B41FA5}">
                      <a16:colId xmlns:a16="http://schemas.microsoft.com/office/drawing/2014/main" val="875546024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1038583810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3820918266"/>
                    </a:ext>
                  </a:extLst>
                </a:gridCol>
                <a:gridCol w="1116000">
                  <a:extLst>
                    <a:ext uri="{9D8B030D-6E8A-4147-A177-3AD203B41FA5}">
                      <a16:colId xmlns:a16="http://schemas.microsoft.com/office/drawing/2014/main" val="410788220"/>
                    </a:ext>
                  </a:extLst>
                </a:gridCol>
                <a:gridCol w="1295999">
                  <a:extLst>
                    <a:ext uri="{9D8B030D-6E8A-4147-A177-3AD203B41FA5}">
                      <a16:colId xmlns:a16="http://schemas.microsoft.com/office/drawing/2014/main" val="3056686124"/>
                    </a:ext>
                  </a:extLst>
                </a:gridCol>
                <a:gridCol w="684001">
                  <a:extLst>
                    <a:ext uri="{9D8B030D-6E8A-4147-A177-3AD203B41FA5}">
                      <a16:colId xmlns:a16="http://schemas.microsoft.com/office/drawing/2014/main" val="112021320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just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UC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 Value</a:t>
                      </a:r>
                      <a:b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(AUC)</a:t>
                      </a:r>
                      <a:endParaRPr lang="de-DE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iscriminatory</a:t>
                      </a: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Value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R (95%CI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-Value OR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28614926"/>
                  </a:ext>
                </a:extLst>
              </a:tr>
              <a:tr h="252000">
                <a:tc gridSpan="6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flammatory</a:t>
                      </a: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Parameter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endParaRPr lang="de-DE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06394859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RP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8 (0.67–0.9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25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7 (0.98–1.17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30327050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erritin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6 (0.62–0.9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4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73.5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01 (1–1.002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47803913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-6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92 (0.85–0.99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0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04 (1.02–1.06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0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5458136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lbumin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84 (0.7–0.97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02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55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3 (0.002–0.17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800"/>
                        </a:spcAft>
                      </a:pPr>
                      <a:r>
                        <a:rPr lang="de-DE" sz="1000" b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0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87873758"/>
                  </a:ext>
                </a:extLst>
              </a:tr>
            </a:tbl>
          </a:graphicData>
        </a:graphic>
      </p:graphicFrame>
      <p:sp>
        <p:nvSpPr>
          <p:cNvPr id="9" name="Rectangle 4">
            <a:extLst>
              <a:ext uri="{FF2B5EF4-FFF2-40B4-BE49-F238E27FC236}">
                <a16:creationId xmlns:a16="http://schemas.microsoft.com/office/drawing/2014/main" id="{E6488B45-E163-49BA-B0FF-E402A09BBAB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1091" y="260472"/>
            <a:ext cx="4919937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de-DE" sz="1000" b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US" altLang="de-DE" sz="1000" b="1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able S4. </a:t>
            </a:r>
            <a:r>
              <a:rPr kumimoji="0" lang="en-US" altLang="de-DE" sz="10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sults of ROC Analyses </a:t>
            </a:r>
            <a:r>
              <a:rPr lang="en-US" altLang="de-DE" sz="10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Odds Ratios of Inflammatory Markers</a:t>
            </a:r>
            <a:endParaRPr kumimoji="0" lang="de-DE" altLang="de-DE" sz="1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4">
            <a:extLst>
              <a:ext uri="{FF2B5EF4-FFF2-40B4-BE49-F238E27FC236}">
                <a16:creationId xmlns:a16="http://schemas.microsoft.com/office/drawing/2014/main" id="{9F817F55-2DEF-43E1-A382-901C51394D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1091" y="2102273"/>
            <a:ext cx="6190629" cy="5539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bbreviations: 95% CI = 95% confidence interval, AUC = area under the curve, </a:t>
            </a:r>
            <a:r>
              <a:rPr kumimoji="0" lang="de-DE" altLang="de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P = c-</a:t>
            </a:r>
            <a:r>
              <a:rPr kumimoji="0" lang="de-DE" altLang="de-DE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active</a:t>
            </a:r>
            <a:r>
              <a:rPr kumimoji="0" lang="de-DE" altLang="de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de-DE" altLang="de-DE" sz="10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rotein</a:t>
            </a:r>
            <a:r>
              <a:rPr kumimoji="0" lang="de-DE" altLang="de-DE" sz="10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IL-6 = interleukin-6, OR = Odds Ratio.</a:t>
            </a:r>
            <a:endParaRPr kumimoji="0" lang="de-DE" altLang="de-DE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de-DE" altLang="de-DE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1420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23</Words>
  <Application>Microsoft Office PowerPoint</Application>
  <PresentationFormat>A4 Paper (210x297 mm)</PresentationFormat>
  <Paragraphs>159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avid Santos</dc:creator>
  <cp:lastModifiedBy>MDPI-133</cp:lastModifiedBy>
  <cp:revision>27</cp:revision>
  <dcterms:created xsi:type="dcterms:W3CDTF">2021-07-19T13:22:03Z</dcterms:created>
  <dcterms:modified xsi:type="dcterms:W3CDTF">2022-10-13T13:34:22Z</dcterms:modified>
</cp:coreProperties>
</file>